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3180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7AF5C-63E3-433F-B081-CD5EB11250C5}" type="datetimeFigureOut">
              <a:rPr lang="de-DE" smtClean="0"/>
              <a:t>31.03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980C-47B0-4F51-94B0-56B2F89E1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9098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7AF5C-63E3-433F-B081-CD5EB11250C5}" type="datetimeFigureOut">
              <a:rPr lang="de-DE" smtClean="0"/>
              <a:t>31.03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980C-47B0-4F51-94B0-56B2F89E1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43790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7AF5C-63E3-433F-B081-CD5EB11250C5}" type="datetimeFigureOut">
              <a:rPr lang="de-DE" smtClean="0"/>
              <a:t>31.03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980C-47B0-4F51-94B0-56B2F89E1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7421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7AF5C-63E3-433F-B081-CD5EB11250C5}" type="datetimeFigureOut">
              <a:rPr lang="de-DE" smtClean="0"/>
              <a:t>31.03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980C-47B0-4F51-94B0-56B2F89E1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5784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7AF5C-63E3-433F-B081-CD5EB11250C5}" type="datetimeFigureOut">
              <a:rPr lang="de-DE" smtClean="0"/>
              <a:t>31.03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980C-47B0-4F51-94B0-56B2F89E1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8938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7AF5C-63E3-433F-B081-CD5EB11250C5}" type="datetimeFigureOut">
              <a:rPr lang="de-DE" smtClean="0"/>
              <a:t>31.03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980C-47B0-4F51-94B0-56B2F89E1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9380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7AF5C-63E3-433F-B081-CD5EB11250C5}" type="datetimeFigureOut">
              <a:rPr lang="de-DE" smtClean="0"/>
              <a:t>31.03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980C-47B0-4F51-94B0-56B2F89E1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4247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7AF5C-63E3-433F-B081-CD5EB11250C5}" type="datetimeFigureOut">
              <a:rPr lang="de-DE" smtClean="0"/>
              <a:t>31.03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980C-47B0-4F51-94B0-56B2F89E1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1951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7AF5C-63E3-433F-B081-CD5EB11250C5}" type="datetimeFigureOut">
              <a:rPr lang="de-DE" smtClean="0"/>
              <a:t>31.03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980C-47B0-4F51-94B0-56B2F89E1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7015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7AF5C-63E3-433F-B081-CD5EB11250C5}" type="datetimeFigureOut">
              <a:rPr lang="de-DE" smtClean="0"/>
              <a:t>31.03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980C-47B0-4F51-94B0-56B2F89E1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1247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7AF5C-63E3-433F-B081-CD5EB11250C5}" type="datetimeFigureOut">
              <a:rPr lang="de-DE" smtClean="0"/>
              <a:t>31.03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980C-47B0-4F51-94B0-56B2F89E1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375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F7AF5C-63E3-433F-B081-CD5EB11250C5}" type="datetimeFigureOut">
              <a:rPr lang="de-DE" smtClean="0"/>
              <a:t>31.03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E6980C-47B0-4F51-94B0-56B2F89E15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9660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192526" y="1403648"/>
            <a:ext cx="7484946" cy="54630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de-AT" sz="1100" b="1" dirty="0">
                <a:latin typeface="Courier" pitchFamily="49" charset="0"/>
                <a:cs typeface="Arial" pitchFamily="34" charset="0"/>
              </a:rPr>
              <a:t>EpEX</a:t>
            </a:r>
            <a:r>
              <a:rPr lang="de-AT" sz="1100" b="1" dirty="0">
                <a:solidFill>
                  <a:srgbClr val="0070C0"/>
                </a:solidFill>
                <a:latin typeface="Courier" pitchFamily="49" charset="0"/>
                <a:cs typeface="Arial" pitchFamily="34" charset="0"/>
              </a:rPr>
              <a:t>-FLAG </a:t>
            </a:r>
            <a:r>
              <a:rPr lang="de-AT" sz="1100" b="1" dirty="0">
                <a:latin typeface="Courier" pitchFamily="49" charset="0"/>
                <a:cs typeface="Arial" pitchFamily="34" charset="0"/>
              </a:rPr>
              <a:t>293 </a:t>
            </a:r>
            <a:r>
              <a:rPr lang="de-AT" sz="1100" b="1" dirty="0" err="1">
                <a:latin typeface="Courier" pitchFamily="49" charset="0"/>
                <a:cs typeface="Arial" pitchFamily="34" charset="0"/>
              </a:rPr>
              <a:t>amino</a:t>
            </a:r>
            <a:r>
              <a:rPr lang="de-AT" sz="1100" b="1" dirty="0">
                <a:latin typeface="Courier" pitchFamily="49" charset="0"/>
                <a:cs typeface="Arial" pitchFamily="34" charset="0"/>
              </a:rPr>
              <a:t> </a:t>
            </a:r>
            <a:r>
              <a:rPr lang="de-AT" sz="1100" b="1" dirty="0" err="1">
                <a:latin typeface="Courier" pitchFamily="49" charset="0"/>
                <a:cs typeface="Arial" pitchFamily="34" charset="0"/>
              </a:rPr>
              <a:t>acids</a:t>
            </a:r>
            <a:endParaRPr lang="de-DE" sz="1100" b="1" dirty="0">
              <a:latin typeface="Courier" pitchFamily="49" charset="0"/>
              <a:cs typeface="Arial" pitchFamily="34" charset="0"/>
            </a:endParaRPr>
          </a:p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100" b="1" i="1" u="sng" dirty="0">
                <a:solidFill>
                  <a:srgbClr val="FF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MAPPQVLAFG LLLAAATATF AAA</a:t>
            </a:r>
            <a:r>
              <a:rPr lang="en-US" sz="1100" b="1" dirty="0">
                <a:solidFill>
                  <a:srgbClr val="FF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E</a:t>
            </a:r>
            <a:r>
              <a:rPr lang="en-US" sz="11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CVCE NYKLAVNCFV NNNRQCQCTS VGAQNTVICS </a:t>
            </a:r>
            <a:endParaRPr lang="en-US" sz="1100" b="1" dirty="0" smtClean="0">
              <a:solidFill>
                <a:srgbClr val="C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LAAKCLVMK </a:t>
            </a:r>
            <a:r>
              <a:rPr lang="en-US" sz="11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EMNGSKLGR RAKPEGALQN NDGLYDPDCD ESGLFKAKQC NGTSTCWCVN</a:t>
            </a:r>
          </a:p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AGVRRTDKD </a:t>
            </a:r>
            <a:r>
              <a:rPr lang="en-US" sz="11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EITCSERVR TYWIIIELKH KAREKPYDSK SLRTALQKEI TTRYQLDPKF   </a:t>
            </a:r>
          </a:p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TSILYENNV </a:t>
            </a:r>
            <a:r>
              <a:rPr lang="en-US" sz="11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TIDLVQNSS QKTQNDVDIA DVAYYFEKDV KGESLFHSKK MDLTVNGEQL  </a:t>
            </a:r>
          </a:p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1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LDPGQTLIY </a:t>
            </a:r>
            <a:r>
              <a:rPr lang="en-US" sz="11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YVDEKAPEFS MQGLK</a:t>
            </a:r>
            <a:r>
              <a:rPr lang="en-US" sz="11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RGSR </a:t>
            </a:r>
            <a:r>
              <a:rPr lang="en-US" sz="1100" b="1" dirty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DYKDHDGDY KDHDIDYKDD DDK</a:t>
            </a:r>
            <a:r>
              <a:rPr lang="de-DE" sz="1100" dirty="0">
                <a:solidFill>
                  <a:srgbClr val="0070C0"/>
                </a:solidFill>
                <a:latin typeface="Courier New" pitchFamily="49" charset="0"/>
                <a:cs typeface="Courier New" pitchFamily="49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lang="en-US" sz="1100" b="1" dirty="0">
              <a:solidFill>
                <a:srgbClr val="C00000"/>
              </a:solidFill>
              <a:latin typeface="Courier" pitchFamily="49" charset="0"/>
              <a:ea typeface="Times New Roman" pitchFamily="18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EpCAM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-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YFP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 559 amino acids</a:t>
            </a:r>
            <a:endParaRPr kumimoji="0" lang="de-DE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" pitchFamily="49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MAPPQVLAFG LLLAAATATF AAAQEECVCE NYKLAVNCFV NNNRQCQCTS VGAQNTVICS KLAAKCLVMK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AEMNGSKLGR RAKPEGALQN NDGLYDPDCD ESGLFKAKQC NGTSTCWCVN TAGVRRTDKD TEITCSERVR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TYWIIIELKH KAREKPYDSK SLRTALQKEI TTRYQLDPKF ITSILYENNV ITIDLVQNSS QKTQNDVDIA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DVAYYFEKDV KGESLFHSKK MDLTVNGEQL DLDPGQTLIY YVDEKAPEFS MQGLKAGVIA VIVVVVIAVV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AG</a:t>
            </a:r>
            <a:r>
              <a:rPr kumimoji="0" lang="en-US" sz="1100" b="1" i="0" u="sng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IVVLVIS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R KKRMAKYEKA EIKEMGEMHR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 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ELNA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GEPVAT 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MVSKGEELFT GVVPILVELD GDVNGHKFSV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SGEGEGDATY GKLTLKFICT TGKLPVPWPT LVTTFGYGLQ CFARYPDHMK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 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QHDFFKSAMP EGYVQERTIF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FKDDGNYKTR AEVKFEGDTL VNRIELKGID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 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FKEDGNILGH KLEYNYNSHN VYIMADKQKN GIKVNFKIRH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NIEDGSVQLA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 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DHYQQNTPIG DGPVLLPDNH YLSYQSALSK DPNEKRDHMV LLEFVTAAGI TLGMDELYK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kumimoji="0" lang="de-DE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" pitchFamily="49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EpICD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-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YFP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 266 amino acids</a:t>
            </a:r>
            <a:endParaRPr kumimoji="0" lang="de-DE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" pitchFamily="49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MAKYEKAEIK EMGEMHRELN A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GEPVAT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MVS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 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KGEELFTGVV PILVELDGDV NGHKFSVSGE GEGDATYGKL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TLKFICTTGK LPVPWPTLVT TFGYGLQCFA RYPDHMKQHD FFKSAMPEGY VQERTIFFKD DGNYKTRAEV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KFEGDTLVNR IELKGIDFKE DGNILGHKLE YNYNSHNVYI MADKQKNGIK VNFKIRHNIE DGSVQLADHY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QQNTPIGDGP VLLPDNHYLS YQSALSKDPN EKRDHMVLLE FVTAAGITLG MDELYK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kumimoji="0" lang="de-DE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" pitchFamily="49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EpEX-TM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-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YFP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 532 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amino acids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MAPPQVLAFG LLLAAATATF AAAQEECVCE NYKLAVNCFV NNNRQCQCTS VGAQNTVICS KLAAKCLVMK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AEMNGSKLGR RAKPEGALQN NDGLYDPDCD ESGLFKAKQC NGTSTCWCVN TAGVRRTDKD TEITCSERVR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TYWIIIELKH KAREKPYDSK SLRTALQKEI TTRYQLDPKF ITSILYENNV ITIDLVQNSS QKTQNDVDIA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DVAYYFEKDV KGESLFHSKK MDLTVNGEQL DLDPGQTLIY YVDEKAPEFS MQGLKAGVIA VIVVVVIAVV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AG</a:t>
            </a:r>
            <a:r>
              <a:rPr kumimoji="0" lang="en-US" sz="1100" b="1" i="0" u="sng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IVVLVIS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P VAT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MVSKGEE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 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LFTGVVPILV ELDGDVNGHK FSVSGEGEGD ATYGKLTLKF ICTTGKLPVP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WPTLVTTFGY GLQCFARYPD HMKQHDFFKS AMPEGYVQER TIFFKDDGNY KTRAEVKFEG DTLVNRIELK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GIDFKEDGNI LGHKLEYNYN SHNVYIMADK QKNGIKVNFK IRHNIEDGSV QLADHYQQNT PIGDGPVLLP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Courier" pitchFamily="49" charset="0"/>
                <a:ea typeface="Times New Roman" pitchFamily="18" charset="0"/>
                <a:cs typeface="Arial" panose="020B0604020202020204" pitchFamily="34" charset="0"/>
              </a:rPr>
              <a:t>DNHYLSYQSA LSKDPNEKRD HMVLLEFVTA AGITLGMDEL Y</a:t>
            </a:r>
            <a:r>
              <a:rPr kumimoji="0" lang="de-DE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" pitchFamily="49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5085184" y="8622457"/>
            <a:ext cx="15714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 err="1" smtClean="0"/>
              <a:t>Suppl</a:t>
            </a:r>
            <a:r>
              <a:rPr lang="de-AT" dirty="0" smtClean="0"/>
              <a:t>. </a:t>
            </a:r>
            <a:r>
              <a:rPr lang="de-AT" dirty="0" err="1" smtClean="0"/>
              <a:t>Figure</a:t>
            </a:r>
            <a:r>
              <a:rPr lang="de-AT" dirty="0" smtClean="0"/>
              <a:t> 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8406462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7</Words>
  <Application>Microsoft Office PowerPoint</Application>
  <PresentationFormat>Bildschirmpräsentation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Tilak Gmb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olekularzytologisches Labor Med. G1 /MA</dc:creator>
  <cp:lastModifiedBy>Molekularzytologisches Labor Med. G1 /MA </cp:lastModifiedBy>
  <cp:revision>4</cp:revision>
  <dcterms:created xsi:type="dcterms:W3CDTF">2015-03-05T09:46:37Z</dcterms:created>
  <dcterms:modified xsi:type="dcterms:W3CDTF">2015-03-31T08:43:13Z</dcterms:modified>
</cp:coreProperties>
</file>